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97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9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5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99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5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5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0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 flipH="1">
            <a:off x="3612428" y="727880"/>
            <a:ext cx="14401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336064" y="827584"/>
            <a:ext cx="2847975" cy="2611315"/>
            <a:chOff x="336064" y="1043608"/>
            <a:chExt cx="2847975" cy="2611315"/>
          </a:xfrm>
        </p:grpSpPr>
        <p:pic>
          <p:nvPicPr>
            <p:cNvPr id="3074" name="Picture 2" descr="CSNP replicates_1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6064" y="1043608"/>
              <a:ext cx="2847975" cy="26113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336064" y="1043608"/>
              <a:ext cx="2126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451820" y="982886"/>
            <a:ext cx="2857500" cy="2523392"/>
            <a:chOff x="3667844" y="1187624"/>
            <a:chExt cx="2857500" cy="2523392"/>
          </a:xfrm>
        </p:grpSpPr>
        <p:pic>
          <p:nvPicPr>
            <p:cNvPr id="3073" name="Picture 299" descr="Nmag replicates_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67844" y="1187624"/>
              <a:ext cx="2857500" cy="25233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Rectangle 9"/>
            <p:cNvSpPr/>
            <p:nvPr/>
          </p:nvSpPr>
          <p:spPr>
            <a:xfrm>
              <a:off x="3720440" y="1196008"/>
              <a:ext cx="2126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/>
          <p:cNvSpPr txBox="1"/>
          <p:nvPr/>
        </p:nvSpPr>
        <p:spPr>
          <a:xfrm flipH="1">
            <a:off x="336064" y="727880"/>
            <a:ext cx="14401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85" r="4813" b="14992"/>
          <a:stretch/>
        </p:blipFill>
        <p:spPr>
          <a:xfrm>
            <a:off x="373244" y="3898978"/>
            <a:ext cx="3362232" cy="2761254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203514" y="4133041"/>
            <a:ext cx="1089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NP mock</a:t>
            </a:r>
            <a:endParaRPr lang="en-US" sz="12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flipH="1">
            <a:off x="336064" y="3616151"/>
            <a:ext cx="14401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C</a:t>
            </a:r>
            <a:endParaRPr lang="en-US" sz="1400" b="1" dirty="0"/>
          </a:p>
        </p:txBody>
      </p:sp>
      <p:sp>
        <p:nvSpPr>
          <p:cNvPr id="5" name="Rectangle 4"/>
          <p:cNvSpPr/>
          <p:nvPr/>
        </p:nvSpPr>
        <p:spPr>
          <a:xfrm>
            <a:off x="480080" y="6940713"/>
            <a:ext cx="58292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Proteomics </a:t>
            </a:r>
            <a:r>
              <a:rPr lang="en-US" sz="1200" b="1" dirty="0"/>
              <a:t>analysis of the plasma protein </a:t>
            </a:r>
            <a:r>
              <a:rPr lang="en-US" sz="1200" b="1" dirty="0" smtClean="0"/>
              <a:t>corona.</a:t>
            </a:r>
            <a:r>
              <a:rPr lang="en-US" sz="1200" dirty="0" smtClean="0"/>
              <a:t> </a:t>
            </a:r>
            <a:r>
              <a:rPr lang="en-US" sz="1200" dirty="0"/>
              <a:t>Good reproducibility in terms of overlap of protein identification was observed for the CSNP (A) and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(B) corona. C.</a:t>
            </a:r>
            <a:r>
              <a:rPr lang="en-US" sz="1200" b="1" dirty="0"/>
              <a:t> </a:t>
            </a:r>
            <a:r>
              <a:rPr lang="en-US" sz="1200" dirty="0"/>
              <a:t>Venn diagram of CSNP and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binding proteins compared to the corresponding mock plasma samples, i.e. plasma samples subjected to the same steps (see </a:t>
            </a:r>
            <a:r>
              <a:rPr lang="en-US" sz="1200" dirty="0" smtClean="0"/>
              <a:t>Fig. </a:t>
            </a:r>
            <a:r>
              <a:rPr lang="en-US" sz="1200" dirty="0"/>
              <a:t>1C).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8716" y="238489"/>
            <a:ext cx="870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4_Fig.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04368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7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eel, Bengt</dc:creator>
  <cp:lastModifiedBy>Fadeel, Bengt </cp:lastModifiedBy>
  <cp:revision>14</cp:revision>
  <cp:lastPrinted>2014-07-10T14:18:30Z</cp:lastPrinted>
  <dcterms:created xsi:type="dcterms:W3CDTF">2014-07-07T17:13:11Z</dcterms:created>
  <dcterms:modified xsi:type="dcterms:W3CDTF">2015-09-05T12:22:01Z</dcterms:modified>
</cp:coreProperties>
</file>